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9BB3DD-E702-4812-8EC5-21F44762AD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BEDF950-F5D0-4780-AEFA-0386A69C0C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ECD92BA-8DD6-4B32-8F97-0C800267F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97F6EE3-0FFD-47FE-B3AE-821769F00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7921CF5-8DB3-4256-B097-D0757DCD2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9665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7940CD-495B-4CFF-8510-AD664DBB0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7E05131-AFE5-4DB0-83C5-E79EB85EFA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F2AEE2B-63FF-40F9-AEE0-5FCA77628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3D0C48D-B8F0-4BCC-A58D-8C36B80E1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0E5935-B697-48E7-8C8A-5F941E984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0390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48BF640-12D8-4854-B35B-FD394031F3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BC38213-230D-4077-A479-AF50A673CF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3B84EEC-6347-47A8-978E-F13EED038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8348219-2215-454B-B765-0F1CD456E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6C5A7A7-730D-4E79-A001-38A8B3D07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54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57D23F-BB23-4905-A815-ACC08375A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AA49DA1-7C05-4F51-961E-6155FFA3C5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B5007C-D917-4290-85A2-C757101FE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2D367C7-BCD4-4D02-8E9A-665C65F43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31C239E-67E9-48CB-8F41-1BED906A1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8447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BCF8A3-18BE-4315-902D-3E353B2166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605E623-6FD4-469B-8251-D360D98514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8DA40E9-9FBF-4BDE-859D-0E657FBB0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79E64B9-A1C1-47B4-AF7C-7DE232B9A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604D208-EDD4-40C0-9FA1-85D7F931E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8091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BAFC60-E090-47BB-B0C9-BA0EE09FB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96813C4-D44C-4097-943D-AEB1BD07E9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C4BC2D6-95CF-492D-A0CD-63FD802865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A02E9BE-68B3-4682-A89B-7B03DDF10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B2367C1-15CB-43F2-B96D-80D8E6D28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E2E1E31-B0FB-41F6-BB67-C9B2CBF78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3660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B35660-CFBC-4DC4-8A41-7F44E853F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91B4D2E-BA77-4B0C-A16D-88E6F0484C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6F6FDD9-B3C8-434C-9FA9-DE37B4A1F2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F454B14-C07D-42D1-8B49-49957EE86F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184553D-3AB4-4B8A-A4E5-040AAC197D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CD25F4D-DCCC-43C6-816F-C03827D64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222528F-A084-4762-ADF4-CE59FB69C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1B0BB0E-0257-4BF8-A56C-C342DE4E0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2288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B5AE64-0DA5-4051-9EA9-ADD03D3623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C3EF747-ECB4-406B-9FF9-7A41C8948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D77FA0D-9D87-4F15-9059-F6D9CA206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D907450-9CBB-47C3-A917-FD523679D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0734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B00E460-97FD-487D-9473-7F45F0FE7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79DDDC3-22A1-4DB6-806E-CD53D41AA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439C836-5175-47DF-A863-0029E992A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992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0B2B718-40D4-4E06-B813-2607121C8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9B3D831-9DC8-4223-AF71-60E38EA7A2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CF4F98E-02B5-4A44-8DC5-3C497AE106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3442BAD-8A74-412F-9C96-D51716169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0AAB176-4004-40A1-8140-0545F8BCF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AD192C1-555F-4F89-92D0-D453082EB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8195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B1C55F1-231A-4C5A-A969-56A0023D0F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AF1E30B-35FF-40A8-950F-BDE37D852F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D9BFAE5-D811-45CB-9346-FE0CA61151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C95110-B838-40A6-B89D-7084C22C2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7AD0BB2-C83C-4D83-900D-1052037A7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3688726-A78F-48DD-BABF-74FDCB0E4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952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85ACB41-C11A-43B6-B102-7DE1853578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2186819-AFAB-4311-95A9-CF8EEC741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D5EF9F6-18A5-4F69-AD1A-E23B3831DC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DF8C7-ADA9-47A2-8333-56CAC02B7A8E}" type="datetimeFigureOut">
              <a:rPr lang="fr-FR" smtClean="0"/>
              <a:t>08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C99DC65-D3C2-4382-8948-E74A3E6867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B320319-36F0-4059-AF65-A08DD25293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437ED-04F2-4D28-9EF4-6902EB60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8294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6A6B5DDE-6BB0-463F-A5A0-4E7ADC522A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2407"/>
            <a:ext cx="12192000" cy="6613185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28B9CD65-D890-4519-8D36-1DFB0EC7D061}"/>
              </a:ext>
            </a:extLst>
          </p:cNvPr>
          <p:cNvSpPr txBox="1"/>
          <p:nvPr/>
        </p:nvSpPr>
        <p:spPr>
          <a:xfrm>
            <a:off x="1227015" y="1078523"/>
            <a:ext cx="40463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/ Left atrial – Pulmonary artery gradient</a:t>
            </a:r>
          </a:p>
          <a:p>
            <a:r>
              <a:rPr lang="fr-FR" dirty="0"/>
              <a:t>H0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AA6EA95D-C862-4460-8469-AAEA0A2F73AC}"/>
              </a:ext>
            </a:extLst>
          </p:cNvPr>
          <p:cNvSpPr txBox="1"/>
          <p:nvPr/>
        </p:nvSpPr>
        <p:spPr>
          <a:xfrm>
            <a:off x="1987062" y="6341403"/>
            <a:ext cx="821059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400" dirty="0"/>
              <a:t>PaO2 alveolar-arterial gradien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8B4E827-6376-48EA-BEC5-90B1ABC4A7CA}"/>
              </a:ext>
            </a:extLst>
          </p:cNvPr>
          <p:cNvSpPr txBox="1"/>
          <p:nvPr/>
        </p:nvSpPr>
        <p:spPr>
          <a:xfrm>
            <a:off x="2153785" y="6495291"/>
            <a:ext cx="518091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400" dirty="0"/>
              <a:t>PaO2/FiO2 ratio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74013BE-C9D8-4A62-BC27-3DFA1C8227F9}"/>
              </a:ext>
            </a:extLst>
          </p:cNvPr>
          <p:cNvSpPr txBox="1"/>
          <p:nvPr/>
        </p:nvSpPr>
        <p:spPr>
          <a:xfrm>
            <a:off x="1997222" y="6228155"/>
            <a:ext cx="979658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400" dirty="0"/>
              <a:t>Capillary-left atrium pressure gradient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49742583-4581-4F59-BA70-E299412EE598}"/>
              </a:ext>
            </a:extLst>
          </p:cNvPr>
          <p:cNvSpPr txBox="1"/>
          <p:nvPr/>
        </p:nvSpPr>
        <p:spPr>
          <a:xfrm>
            <a:off x="1669757" y="6084502"/>
            <a:ext cx="1442550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400" dirty="0"/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1897534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ED00DC6A-81AC-4A31-9797-C6C3673CEB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720"/>
            <a:ext cx="12192000" cy="676656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42DA1C9-D3E2-42E4-8F9A-E4D3A4027082}"/>
              </a:ext>
            </a:extLst>
          </p:cNvPr>
          <p:cNvSpPr txBox="1"/>
          <p:nvPr/>
        </p:nvSpPr>
        <p:spPr>
          <a:xfrm>
            <a:off x="1227015" y="1078523"/>
            <a:ext cx="40382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/ Left atrial – Pulmonary artery gradient</a:t>
            </a:r>
          </a:p>
          <a:p>
            <a:r>
              <a:rPr lang="fr-FR" dirty="0"/>
              <a:t>H0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E74925EC-5E0A-4704-8B15-E575A3456B7E}"/>
              </a:ext>
            </a:extLst>
          </p:cNvPr>
          <p:cNvSpPr txBox="1"/>
          <p:nvPr/>
        </p:nvSpPr>
        <p:spPr>
          <a:xfrm>
            <a:off x="1880382" y="6440463"/>
            <a:ext cx="821059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400" dirty="0"/>
              <a:t>PaO2 alveolar-arterial gradient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DA1DBDB-DD04-47DA-AE7F-3EB8F95BC038}"/>
              </a:ext>
            </a:extLst>
          </p:cNvPr>
          <p:cNvSpPr txBox="1"/>
          <p:nvPr/>
        </p:nvSpPr>
        <p:spPr>
          <a:xfrm>
            <a:off x="2059805" y="6594351"/>
            <a:ext cx="518091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400" dirty="0"/>
              <a:t>PaO2/FiO2 ratio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B74D4D2-EFF1-45D0-981C-E89EF10C3AC7}"/>
              </a:ext>
            </a:extLst>
          </p:cNvPr>
          <p:cNvSpPr txBox="1"/>
          <p:nvPr/>
        </p:nvSpPr>
        <p:spPr>
          <a:xfrm>
            <a:off x="1865142" y="6327215"/>
            <a:ext cx="979658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400" dirty="0"/>
              <a:t>Capillary-left atrium pressure gradien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F1D9CB3-607A-41D6-BCF5-8C123238CA76}"/>
              </a:ext>
            </a:extLst>
          </p:cNvPr>
          <p:cNvSpPr txBox="1"/>
          <p:nvPr/>
        </p:nvSpPr>
        <p:spPr>
          <a:xfrm>
            <a:off x="1537677" y="6183562"/>
            <a:ext cx="1442550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400" dirty="0"/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24278362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A2F0844A-FC9E-44CB-8454-B06A60D6FF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454" y="0"/>
            <a:ext cx="11603091" cy="6858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3C22B1F7-2B85-4784-BAC1-04C715D110FE}"/>
              </a:ext>
            </a:extLst>
          </p:cNvPr>
          <p:cNvSpPr txBox="1"/>
          <p:nvPr/>
        </p:nvSpPr>
        <p:spPr>
          <a:xfrm>
            <a:off x="1227015" y="1078523"/>
            <a:ext cx="40366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/ Left atrial – Pulmonary artery gradient</a:t>
            </a:r>
          </a:p>
          <a:p>
            <a:r>
              <a:rPr lang="fr-FR" dirty="0"/>
              <a:t>H0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FD517FCF-B765-45D3-946A-F51D301F14DC}"/>
              </a:ext>
            </a:extLst>
          </p:cNvPr>
          <p:cNvSpPr txBox="1"/>
          <p:nvPr/>
        </p:nvSpPr>
        <p:spPr>
          <a:xfrm>
            <a:off x="1898162" y="6446798"/>
            <a:ext cx="821059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400" dirty="0"/>
              <a:t>PaO2 alveolar-arterial gradient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46B8290-4442-473E-95DC-CDF524F456DD}"/>
              </a:ext>
            </a:extLst>
          </p:cNvPr>
          <p:cNvSpPr txBox="1"/>
          <p:nvPr/>
        </p:nvSpPr>
        <p:spPr>
          <a:xfrm>
            <a:off x="2049645" y="6598071"/>
            <a:ext cx="518091" cy="15388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FR" sz="400" dirty="0"/>
              <a:t>PaO2/FiO2 ratio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B55B300-1326-41D4-917D-8EAEACEE4CCA}"/>
              </a:ext>
            </a:extLst>
          </p:cNvPr>
          <p:cNvSpPr txBox="1"/>
          <p:nvPr/>
        </p:nvSpPr>
        <p:spPr>
          <a:xfrm>
            <a:off x="1931182" y="6261175"/>
            <a:ext cx="979658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400" dirty="0"/>
              <a:t>Capillary-left atrium pressure gradien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1313EDF-28A8-4838-92DB-E5F75A6CADA3}"/>
              </a:ext>
            </a:extLst>
          </p:cNvPr>
          <p:cNvSpPr txBox="1"/>
          <p:nvPr/>
        </p:nvSpPr>
        <p:spPr>
          <a:xfrm>
            <a:off x="1621497" y="6109902"/>
            <a:ext cx="1442550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400" dirty="0"/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3176222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A90B7BDF-550D-45B2-B48F-D81BE72280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8502"/>
            <a:ext cx="12192000" cy="6540995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EB74BE5C-6982-492C-8813-6BA944150DA4}"/>
              </a:ext>
            </a:extLst>
          </p:cNvPr>
          <p:cNvSpPr txBox="1"/>
          <p:nvPr/>
        </p:nvSpPr>
        <p:spPr>
          <a:xfrm>
            <a:off x="1227015" y="1078523"/>
            <a:ext cx="40559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D/ Left atrial – Pulmonary artery gradient</a:t>
            </a:r>
          </a:p>
          <a:p>
            <a:r>
              <a:rPr lang="fr-FR" dirty="0"/>
              <a:t>H0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D19182A-4665-4451-82B0-AA64701E37BC}"/>
              </a:ext>
            </a:extLst>
          </p:cNvPr>
          <p:cNvSpPr/>
          <p:nvPr/>
        </p:nvSpPr>
        <p:spPr>
          <a:xfrm>
            <a:off x="2268855" y="6558558"/>
            <a:ext cx="373380" cy="668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/FiO2 ratio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1E6B3EB-65C8-47E0-B93F-57EF251A99B9}"/>
              </a:ext>
            </a:extLst>
          </p:cNvPr>
          <p:cNvSpPr/>
          <p:nvPr/>
        </p:nvSpPr>
        <p:spPr>
          <a:xfrm>
            <a:off x="2129790" y="6455790"/>
            <a:ext cx="607846" cy="668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 alveolar-arterial gradient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0A7F461-85F9-4704-8E71-5EB8D9332AC5}"/>
              </a:ext>
            </a:extLst>
          </p:cNvPr>
          <p:cNvSpPr/>
          <p:nvPr/>
        </p:nvSpPr>
        <p:spPr>
          <a:xfrm>
            <a:off x="2215515" y="6366745"/>
            <a:ext cx="607846" cy="668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Capillary-left atrium pressure gradient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263C7CF-FBC7-4E24-BEA4-7D5B1698FC3A}"/>
              </a:ext>
            </a:extLst>
          </p:cNvPr>
          <p:cNvSpPr/>
          <p:nvPr/>
        </p:nvSpPr>
        <p:spPr>
          <a:xfrm>
            <a:off x="1945005" y="6277700"/>
            <a:ext cx="977416" cy="668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31276192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8BF9D310-1C1C-4573-9419-74843B6873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3" y="0"/>
            <a:ext cx="12181974" cy="6858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8C984D61-1575-4186-A492-4D7A18143E8E}"/>
              </a:ext>
            </a:extLst>
          </p:cNvPr>
          <p:cNvSpPr txBox="1"/>
          <p:nvPr/>
        </p:nvSpPr>
        <p:spPr>
          <a:xfrm>
            <a:off x="1227015" y="1078523"/>
            <a:ext cx="40254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/ Left atrial – Pulmonary artery gradient</a:t>
            </a:r>
          </a:p>
          <a:p>
            <a:r>
              <a:rPr lang="fr-FR" dirty="0"/>
              <a:t>H24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7B116A0-9790-4024-800D-384419C34A15}"/>
              </a:ext>
            </a:extLst>
          </p:cNvPr>
          <p:cNvSpPr/>
          <p:nvPr/>
        </p:nvSpPr>
        <p:spPr>
          <a:xfrm>
            <a:off x="2152650" y="6656071"/>
            <a:ext cx="373380" cy="104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/FiO2 ratio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4CEB86E-1838-4801-B836-C2266E4EE767}"/>
              </a:ext>
            </a:extLst>
          </p:cNvPr>
          <p:cNvSpPr/>
          <p:nvPr/>
        </p:nvSpPr>
        <p:spPr>
          <a:xfrm>
            <a:off x="2059305" y="6509386"/>
            <a:ext cx="607846" cy="910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 alveolar-arterial gradient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9CA7E44-74AD-4BC5-BF46-80EE7EF1F865}"/>
              </a:ext>
            </a:extLst>
          </p:cNvPr>
          <p:cNvSpPr/>
          <p:nvPr/>
        </p:nvSpPr>
        <p:spPr>
          <a:xfrm>
            <a:off x="2222107" y="6355081"/>
            <a:ext cx="607846" cy="1239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Capillary-left atrium pressure gradien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88BF5EC-085D-4273-9E77-485C23118D6B}"/>
              </a:ext>
            </a:extLst>
          </p:cNvPr>
          <p:cNvSpPr/>
          <p:nvPr/>
        </p:nvSpPr>
        <p:spPr>
          <a:xfrm>
            <a:off x="1992630" y="6198871"/>
            <a:ext cx="977416" cy="1075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39591660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CC6B0FA4-70B3-476A-A3D1-D8AD58435E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8970" y="0"/>
            <a:ext cx="10354060" cy="6858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B1F894EA-94E1-4FC4-8190-8FC9F12BA9B7}"/>
              </a:ext>
            </a:extLst>
          </p:cNvPr>
          <p:cNvSpPr txBox="1"/>
          <p:nvPr/>
        </p:nvSpPr>
        <p:spPr>
          <a:xfrm>
            <a:off x="1227015" y="1078523"/>
            <a:ext cx="40117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/ Left atrial – Pulmonary artery gradient</a:t>
            </a:r>
          </a:p>
          <a:p>
            <a:r>
              <a:rPr lang="fr-FR" dirty="0"/>
              <a:t>H24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F3B402B-D333-4BBE-AA4B-FBB8A27457D6}"/>
              </a:ext>
            </a:extLst>
          </p:cNvPr>
          <p:cNvSpPr/>
          <p:nvPr/>
        </p:nvSpPr>
        <p:spPr>
          <a:xfrm>
            <a:off x="2143125" y="6682190"/>
            <a:ext cx="373380" cy="104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/FiO2 ratio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F46E3FA-4638-4C0B-B8E9-5C3E2F9836C2}"/>
              </a:ext>
            </a:extLst>
          </p:cNvPr>
          <p:cNvSpPr/>
          <p:nvPr/>
        </p:nvSpPr>
        <p:spPr>
          <a:xfrm>
            <a:off x="2025892" y="6539246"/>
            <a:ext cx="607846" cy="910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 alveolar-arterial gradient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78E2801-9480-44EE-8B9A-974A93889E72}"/>
              </a:ext>
            </a:extLst>
          </p:cNvPr>
          <p:cNvSpPr/>
          <p:nvPr/>
        </p:nvSpPr>
        <p:spPr>
          <a:xfrm>
            <a:off x="2164957" y="6412231"/>
            <a:ext cx="607846" cy="1239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Capillary-left atrium pressure gradien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3A2C396-0924-44B4-A890-C2CDC8E2F3EA}"/>
              </a:ext>
            </a:extLst>
          </p:cNvPr>
          <p:cNvSpPr/>
          <p:nvPr/>
        </p:nvSpPr>
        <p:spPr>
          <a:xfrm>
            <a:off x="1935480" y="6256021"/>
            <a:ext cx="977416" cy="1075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1443139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508EA90-FA06-4462-96F4-6CFE84AD49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584" y="0"/>
            <a:ext cx="11228832" cy="6858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9F286F7-2D54-42E5-A62A-6BA9EF74D407}"/>
              </a:ext>
            </a:extLst>
          </p:cNvPr>
          <p:cNvSpPr txBox="1"/>
          <p:nvPr/>
        </p:nvSpPr>
        <p:spPr>
          <a:xfrm>
            <a:off x="1227015" y="1078523"/>
            <a:ext cx="40591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/ Left atrial – Pulmonary artery gradient</a:t>
            </a:r>
          </a:p>
          <a:p>
            <a:r>
              <a:rPr lang="fr-FR" dirty="0"/>
              <a:t>H24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6F01B96-AE4F-471B-B574-B8EA36653162}"/>
              </a:ext>
            </a:extLst>
          </p:cNvPr>
          <p:cNvSpPr/>
          <p:nvPr/>
        </p:nvSpPr>
        <p:spPr>
          <a:xfrm>
            <a:off x="2169795" y="6632768"/>
            <a:ext cx="373380" cy="104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/FiO2 ratio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33F7C2D-F06C-4C82-AF13-1B1BBC759F52}"/>
              </a:ext>
            </a:extLst>
          </p:cNvPr>
          <p:cNvSpPr/>
          <p:nvPr/>
        </p:nvSpPr>
        <p:spPr>
          <a:xfrm>
            <a:off x="2103120" y="6480811"/>
            <a:ext cx="607846" cy="910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 alveolar-arterial gradient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8CDD792-3E56-42B6-B60A-7E4E90962519}"/>
              </a:ext>
            </a:extLst>
          </p:cNvPr>
          <p:cNvSpPr/>
          <p:nvPr/>
        </p:nvSpPr>
        <p:spPr>
          <a:xfrm>
            <a:off x="2281162" y="6296026"/>
            <a:ext cx="607846" cy="1239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Capillary-left atrium pressure gradien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ADB81D6-0EF8-4D22-8CEF-3E76A5CD7BCD}"/>
              </a:ext>
            </a:extLst>
          </p:cNvPr>
          <p:cNvSpPr/>
          <p:nvPr/>
        </p:nvSpPr>
        <p:spPr>
          <a:xfrm>
            <a:off x="2076450" y="6139816"/>
            <a:ext cx="977416" cy="1075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34064146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3673121-66C1-4E28-8B46-51D7782150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249" y="0"/>
            <a:ext cx="11187501" cy="6858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502A6A7E-2EF2-41CA-9BA0-FE07611F798E}"/>
              </a:ext>
            </a:extLst>
          </p:cNvPr>
          <p:cNvSpPr txBox="1"/>
          <p:nvPr/>
        </p:nvSpPr>
        <p:spPr>
          <a:xfrm>
            <a:off x="1227015" y="1078523"/>
            <a:ext cx="40575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H/ Left atrial – Pulmonary artery gradient</a:t>
            </a:r>
          </a:p>
          <a:p>
            <a:r>
              <a:rPr lang="fr-FR" dirty="0"/>
              <a:t>H24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CD7CCA8-A06D-4C8C-B4B7-F55DE9CF6C15}"/>
              </a:ext>
            </a:extLst>
          </p:cNvPr>
          <p:cNvSpPr/>
          <p:nvPr/>
        </p:nvSpPr>
        <p:spPr>
          <a:xfrm>
            <a:off x="2102243" y="6705612"/>
            <a:ext cx="373380" cy="1046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/FiO2 ratio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5E9B59F-297D-44C7-AF8B-3579590B4766}"/>
              </a:ext>
            </a:extLst>
          </p:cNvPr>
          <p:cNvSpPr/>
          <p:nvPr/>
        </p:nvSpPr>
        <p:spPr>
          <a:xfrm>
            <a:off x="1969770" y="6593248"/>
            <a:ext cx="607846" cy="910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aO2 alveolar-arterial gradient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2410894-0EE4-456B-96B1-BF8B0AB61175}"/>
              </a:ext>
            </a:extLst>
          </p:cNvPr>
          <p:cNvSpPr/>
          <p:nvPr/>
        </p:nvSpPr>
        <p:spPr>
          <a:xfrm>
            <a:off x="2073517" y="6488606"/>
            <a:ext cx="607846" cy="910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Capillary-left atrium pressure gradien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DA569C6-B3A6-413B-BF5B-E78A24451A2C}"/>
              </a:ext>
            </a:extLst>
          </p:cNvPr>
          <p:cNvSpPr/>
          <p:nvPr/>
        </p:nvSpPr>
        <p:spPr>
          <a:xfrm>
            <a:off x="1800225" y="6412674"/>
            <a:ext cx="977416" cy="629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>
            <a:noAutofit/>
          </a:bodyPr>
          <a:lstStyle/>
          <a:p>
            <a:pPr algn="r"/>
            <a:r>
              <a:rPr lang="fr-FR" sz="300" dirty="0">
                <a:solidFill>
                  <a:schemeClr val="tx1"/>
                </a:solidFill>
              </a:rPr>
              <a:t>Pulmonary venous resistances/Total pulmonary resistances</a:t>
            </a:r>
          </a:p>
        </p:txBody>
      </p:sp>
    </p:spTree>
    <p:extLst>
      <p:ext uri="{BB962C8B-B14F-4D97-AF65-F5344CB8AC3E}">
        <p14:creationId xmlns:p14="http://schemas.microsoft.com/office/powerpoint/2010/main" val="106797312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6</Words>
  <Application>Microsoft Office PowerPoint</Application>
  <PresentationFormat>Grand écran</PresentationFormat>
  <Paragraphs>48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njamin Deniau</dc:creator>
  <cp:lastModifiedBy>Benjamin Deniau</cp:lastModifiedBy>
  <cp:revision>7</cp:revision>
  <dcterms:created xsi:type="dcterms:W3CDTF">2025-03-06T21:43:28Z</dcterms:created>
  <dcterms:modified xsi:type="dcterms:W3CDTF">2025-03-08T11:07:54Z</dcterms:modified>
</cp:coreProperties>
</file>